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0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1" autoAdjust="0"/>
    <p:restoredTop sz="94660"/>
  </p:normalViewPr>
  <p:slideViewPr>
    <p:cSldViewPr snapToGrid="0">
      <p:cViewPr>
        <p:scale>
          <a:sx n="100" d="100"/>
          <a:sy n="100" d="100"/>
        </p:scale>
        <p:origin x="4608" y="-7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2F5A0F0-2000-C241-BE70-646D1E866BF9}" type="datetimeFigureOut">
              <a:rPr lang="en-US" smtClean="0"/>
              <a:t>10/1/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4655036-EF83-0E49-A50F-CF4F0CC126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172728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42036-6C1A-46F7-BFF2-0B7242D6C537}" type="datetimeFigureOut">
              <a:rPr lang="it-IT" smtClean="0"/>
              <a:t>01/10/18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6115D-F818-4775-B947-F693302171A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508278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42036-6C1A-46F7-BFF2-0B7242D6C537}" type="datetimeFigureOut">
              <a:rPr lang="it-IT" smtClean="0"/>
              <a:t>01/10/18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6115D-F818-4775-B947-F693302171A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066349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42036-6C1A-46F7-BFF2-0B7242D6C537}" type="datetimeFigureOut">
              <a:rPr lang="it-IT" smtClean="0"/>
              <a:t>01/10/18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6115D-F818-4775-B947-F693302171A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223905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42036-6C1A-46F7-BFF2-0B7242D6C537}" type="datetimeFigureOut">
              <a:rPr lang="it-IT" smtClean="0"/>
              <a:t>01/10/18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6115D-F818-4775-B947-F693302171A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299133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42036-6C1A-46F7-BFF2-0B7242D6C537}" type="datetimeFigureOut">
              <a:rPr lang="it-IT" smtClean="0"/>
              <a:t>01/10/18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6115D-F818-4775-B947-F693302171A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643533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42036-6C1A-46F7-BFF2-0B7242D6C537}" type="datetimeFigureOut">
              <a:rPr lang="it-IT" smtClean="0"/>
              <a:t>01/10/18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6115D-F818-4775-B947-F693302171A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857137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42036-6C1A-46F7-BFF2-0B7242D6C537}" type="datetimeFigureOut">
              <a:rPr lang="it-IT" smtClean="0"/>
              <a:t>01/10/18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6115D-F818-4775-B947-F693302171A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36706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42036-6C1A-46F7-BFF2-0B7242D6C537}" type="datetimeFigureOut">
              <a:rPr lang="it-IT" smtClean="0"/>
              <a:t>01/10/18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6115D-F818-4775-B947-F693302171A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012150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42036-6C1A-46F7-BFF2-0B7242D6C537}" type="datetimeFigureOut">
              <a:rPr lang="it-IT" smtClean="0"/>
              <a:t>01/10/18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6115D-F818-4775-B947-F693302171A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438507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42036-6C1A-46F7-BFF2-0B7242D6C537}" type="datetimeFigureOut">
              <a:rPr lang="it-IT" smtClean="0"/>
              <a:t>01/10/18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6115D-F818-4775-B947-F693302171A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457551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42036-6C1A-46F7-BFF2-0B7242D6C537}" type="datetimeFigureOut">
              <a:rPr lang="it-IT" smtClean="0"/>
              <a:t>01/10/18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6115D-F818-4775-B947-F693302171A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395386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B42036-6C1A-46F7-BFF2-0B7242D6C537}" type="datetimeFigureOut">
              <a:rPr lang="it-IT" smtClean="0"/>
              <a:t>01/10/18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06115D-F818-4775-B947-F693302171A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773427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58950" y="1771650"/>
            <a:ext cx="2774950" cy="3884930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393468" y="6337385"/>
            <a:ext cx="5816831" cy="258532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b="1" dirty="0">
                <a:latin typeface="Times New Roman" charset="0"/>
                <a:ea typeface="Calibri" charset="0"/>
                <a:cs typeface="Times New Roman" charset="0"/>
              </a:rPr>
              <a:t>Additional file </a:t>
            </a:r>
            <a:r>
              <a:rPr lang="en-GB" b="1" dirty="0" smtClean="0">
                <a:latin typeface="Times New Roman" charset="0"/>
                <a:ea typeface="Calibri" charset="0"/>
                <a:cs typeface="Times New Roman" charset="0"/>
              </a:rPr>
              <a:t>6:</a:t>
            </a: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b="1" dirty="0" smtClean="0">
                <a:latin typeface="Times New Roman" charset="0"/>
                <a:ea typeface="Calibri" charset="0"/>
                <a:cs typeface="Times New Roman" charset="0"/>
              </a:rPr>
              <a:t>Distance travelled </a:t>
            </a:r>
          </a:p>
          <a:p>
            <a:pPr algn="just">
              <a:lnSpc>
                <a:spcPct val="150000"/>
              </a:lnSpc>
            </a:pPr>
            <a:r>
              <a:rPr lang="en-GB" dirty="0">
                <a:latin typeface="Times New Roman" charset="0"/>
                <a:ea typeface="Calibri" charset="0"/>
                <a:cs typeface="Times New Roman" charset="0"/>
              </a:rPr>
              <a:t>The distance travelled was measured for 10 minutes at the end of the test days in all experimental groups, no differences were found between the groups. </a:t>
            </a: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endParaRPr lang="en-GB" dirty="0">
              <a:latin typeface="Times New Roman" charset="0"/>
              <a:ea typeface="Calibri" charset="0"/>
              <a:cs typeface="Times New Roman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120120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6</TotalTime>
  <Words>34</Words>
  <Application>Microsoft Macintosh PowerPoint</Application>
  <PresentationFormat>Widescreen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Calibri</vt:lpstr>
      <vt:lpstr>Calibri Light</vt:lpstr>
      <vt:lpstr>Times New Roman</vt:lpstr>
      <vt:lpstr>Arial</vt:lpstr>
      <vt:lpstr>Office Theme</vt:lpstr>
      <vt:lpstr>PowerPoint Presentation</vt:lpstr>
    </vt:vector>
  </TitlesOfParts>
  <LinksUpToDate>false</LinksUpToDate>
  <SharedDoc>false</SharedDoc>
  <HyperlinksChanged>false</HyperlinksChanged>
  <AppVersion>15.004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iara</dc:creator>
  <cp:lastModifiedBy>Fabio Di Domenico</cp:lastModifiedBy>
  <cp:revision>22</cp:revision>
  <dcterms:created xsi:type="dcterms:W3CDTF">2018-05-09T09:13:07Z</dcterms:created>
  <dcterms:modified xsi:type="dcterms:W3CDTF">2018-10-01T09:43:07Z</dcterms:modified>
</cp:coreProperties>
</file>